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9" r:id="rId2"/>
    <p:sldId id="260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B07EC4-2E23-4B57-AEA6-16E7CB6B381F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A9EB28-3A7B-4CB9-9699-0B24E2E4B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410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1A2AAD-E0F7-6BBB-1910-698A78C3BA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4BC775-9167-D42D-B614-7A59825E79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748EFE-97ED-D54D-4FFB-58F77E289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551E17-18A8-CE5F-6780-F4D7AC1D7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6A6DDF-A3D6-5428-E6EB-194755662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51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BE065-4141-CE37-B0C8-8A520A8B8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9960BD-3BF9-7DD3-68E1-9CC00B427F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E0CEFE-CE51-64E6-B4E5-CDB828242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90985B-AC72-C93D-1D29-19C4CA678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96639D-2E6A-D84A-7CDF-F129D8034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107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2E715F-3B55-7E20-5BED-71C6249136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C7B852-23CC-248F-3BD7-E5A76932B6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84236E-1C5B-C9C6-9ED5-70FBA5CA0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42397A-CD19-16E9-3429-0878B2090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63EE50-2361-B0FF-190A-F8D71F9C2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808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46F3C-131C-FD9A-3C3D-5F6F3B104A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F356CC-5AB9-6B73-7AB9-D8BB49355F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AC1997-901C-8D75-067C-05C27AE42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3AF164-D1DF-0C02-5F0C-C18511D42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A63350-4A67-8B4D-0208-4CC465195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031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B83DD5-A946-B77F-5411-BED34CAEFE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E0AF27-4003-C2EE-1A6A-B06056E23D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AFB1DE-4A20-A4D1-F4F2-8D0A16FBA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0A0F79-FFFE-27F4-4A90-BC7B8B742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78A409-7901-D559-5F9B-0B9193145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565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012D1B-C8EF-4742-FFEE-BCBCD1987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767404-00C0-CD86-C307-5E4CFF83ED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B7B8D8-D00F-F89E-A7AD-D632314164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0333BD-EF9C-4FD6-96A6-900AC13EE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02EFC6-2AEE-FC53-7DDC-821431754B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71FE01-CBD6-E6F2-123D-78E383A13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72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B6D710-99FE-3312-15B6-57F79F8B8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67A509-9554-110F-DEB4-E14087DD61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3F5299-471B-84FB-98D5-5FE8CE87ED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9EE41B-866B-0829-8F4F-629E6B47FD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7D8B78-EB3C-3FD8-82CD-A7A779484B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0CB81A-225B-3B83-1F08-6540AB3AE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4FB60A-D5A0-09C5-7978-45484936C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25A3A3-0A95-B0B8-F058-DC08C1065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338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89738-7405-E25C-AAD1-D2DB58499A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045C66-4990-A083-F69F-D7FA652D0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C620FC-F19A-D2B5-8A7A-D6604E4BC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272C71-EB2B-ECEE-5BC3-34AEFCF17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441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4D64A1-2754-B562-451F-6A54080A0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C6ED2F4-4C2A-081C-1600-457019149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1FD40F-BFA4-B381-8B00-E4212FC64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88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EC5048-9756-3771-65B1-0A10D8A94F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A12EF9-1508-D510-973F-0BD4A5403F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B77FCC-C370-8621-C207-96F506A8F4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4520E7-3DE9-F373-1DDA-8D9EB75D5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53CC06-A910-7AA7-0BAC-7B2D0824B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0BD87B-8362-D963-E42D-A8B59782D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931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467B22-E1AF-F86B-8177-4EAB62788E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1A42CB-D7C2-AF58-3866-9F9CB3DB59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D74AE1-2DA0-1775-BD0B-686E622E15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461573-64B8-F8E1-857A-13833DD3B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C82328-6A67-4F52-FA8D-1A98DE673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541899-9112-FBC5-AEDD-932461F17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424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21BA15-ED19-86C9-F74D-74077E4FB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F34E01-0CE8-2399-A046-FC1A36F215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771E01-33E3-A58B-A353-1D1F373855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BE32E2-2947-4BF3-8BD0-A9F01787009C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912763-DBFC-8D3C-9306-A289A2906E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DAFD14-F788-8F99-A1FB-632DA4B9F8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CA7927-7D52-4AA2-A51D-9C33E4407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120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2985" r="6457" b="31343"/>
          <a:stretch/>
        </p:blipFill>
        <p:spPr>
          <a:xfrm>
            <a:off x="1524000" y="2322576"/>
            <a:ext cx="6846098" cy="80467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3326" b="55889"/>
          <a:stretch/>
        </p:blipFill>
        <p:spPr>
          <a:xfrm>
            <a:off x="1524000" y="1231892"/>
            <a:ext cx="6846098" cy="107239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/>
          <a:srcRect t="30011" b="24319"/>
          <a:stretch/>
        </p:blipFill>
        <p:spPr>
          <a:xfrm rot="150421">
            <a:off x="1534634" y="3262445"/>
            <a:ext cx="7031776" cy="6400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77240" y="1491091"/>
            <a:ext cx="729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ER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900493" y="2545047"/>
            <a:ext cx="482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R</a:t>
            </a:r>
            <a:r>
              <a:rPr lang="el-GR" sz="1200" dirty="0"/>
              <a:t>α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707326" y="3318243"/>
            <a:ext cx="729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</a:p>
        </p:txBody>
      </p:sp>
      <p:sp>
        <p:nvSpPr>
          <p:cNvPr id="13" name="TextBox 12"/>
          <p:cNvSpPr txBox="1"/>
          <p:nvPr/>
        </p:nvSpPr>
        <p:spPr>
          <a:xfrm rot="3276555">
            <a:off x="2343801" y="4393218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M134 </a:t>
            </a:r>
          </a:p>
        </p:txBody>
      </p:sp>
      <p:sp>
        <p:nvSpPr>
          <p:cNvPr id="16" name="TextBox 15"/>
          <p:cNvSpPr txBox="1"/>
          <p:nvPr/>
        </p:nvSpPr>
        <p:spPr>
          <a:xfrm rot="3276555">
            <a:off x="2788810" y="4393219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M134 </a:t>
            </a:r>
            <a:r>
              <a:rPr lang="en-US" sz="1200" b="1" dirty="0" err="1"/>
              <a:t>TamR</a:t>
            </a:r>
            <a:r>
              <a:rPr lang="en-US" sz="1200" b="1" dirty="0"/>
              <a:t> 100 </a:t>
            </a:r>
          </a:p>
        </p:txBody>
      </p:sp>
      <p:sp>
        <p:nvSpPr>
          <p:cNvPr id="17" name="TextBox 16"/>
          <p:cNvSpPr txBox="1"/>
          <p:nvPr/>
        </p:nvSpPr>
        <p:spPr>
          <a:xfrm rot="3276555">
            <a:off x="3233820" y="4384073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M134 </a:t>
            </a:r>
            <a:r>
              <a:rPr lang="en-US" sz="1200" b="1" dirty="0" err="1"/>
              <a:t>TamR</a:t>
            </a:r>
            <a:r>
              <a:rPr lang="en-US" sz="1200" b="1" dirty="0"/>
              <a:t> 200 </a:t>
            </a:r>
          </a:p>
        </p:txBody>
      </p:sp>
      <p:sp>
        <p:nvSpPr>
          <p:cNvPr id="18" name="TextBox 17"/>
          <p:cNvSpPr txBox="1"/>
          <p:nvPr/>
        </p:nvSpPr>
        <p:spPr>
          <a:xfrm rot="3276555">
            <a:off x="3597974" y="4402365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M134 LTED A </a:t>
            </a:r>
          </a:p>
        </p:txBody>
      </p:sp>
      <p:sp>
        <p:nvSpPr>
          <p:cNvPr id="19" name="TextBox 18"/>
          <p:cNvSpPr txBox="1"/>
          <p:nvPr/>
        </p:nvSpPr>
        <p:spPr>
          <a:xfrm rot="3276555">
            <a:off x="4021455" y="4427770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M134 LTED B </a:t>
            </a:r>
          </a:p>
        </p:txBody>
      </p:sp>
      <p:sp>
        <p:nvSpPr>
          <p:cNvPr id="20" name="TextBox 19"/>
          <p:cNvSpPr txBox="1"/>
          <p:nvPr/>
        </p:nvSpPr>
        <p:spPr>
          <a:xfrm rot="3276555">
            <a:off x="4407139" y="4427767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M134 LTED D </a:t>
            </a:r>
          </a:p>
        </p:txBody>
      </p:sp>
      <p:sp>
        <p:nvSpPr>
          <p:cNvPr id="21" name="TextBox 20"/>
          <p:cNvSpPr txBox="1"/>
          <p:nvPr/>
        </p:nvSpPr>
        <p:spPr>
          <a:xfrm rot="3276555">
            <a:off x="4824715" y="4453169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M134 LTED E</a:t>
            </a:r>
          </a:p>
        </p:txBody>
      </p:sp>
      <p:sp>
        <p:nvSpPr>
          <p:cNvPr id="22" name="TextBox 21"/>
          <p:cNvSpPr txBox="1"/>
          <p:nvPr/>
        </p:nvSpPr>
        <p:spPr>
          <a:xfrm rot="3276555">
            <a:off x="5222339" y="4440468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M44PE</a:t>
            </a:r>
          </a:p>
        </p:txBody>
      </p:sp>
      <p:sp>
        <p:nvSpPr>
          <p:cNvPr id="23" name="TextBox 22"/>
          <p:cNvSpPr txBox="1"/>
          <p:nvPr/>
        </p:nvSpPr>
        <p:spPr>
          <a:xfrm rot="3276555">
            <a:off x="5639974" y="4486451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M44PE </a:t>
            </a:r>
            <a:r>
              <a:rPr lang="en-US" sz="1200" b="1" dirty="0" err="1"/>
              <a:t>TamR</a:t>
            </a:r>
            <a:r>
              <a:rPr lang="en-US" sz="1200" b="1" dirty="0"/>
              <a:t> 100</a:t>
            </a:r>
          </a:p>
        </p:txBody>
      </p:sp>
      <p:sp>
        <p:nvSpPr>
          <p:cNvPr id="24" name="TextBox 23"/>
          <p:cNvSpPr txBox="1"/>
          <p:nvPr/>
        </p:nvSpPr>
        <p:spPr>
          <a:xfrm rot="3276555">
            <a:off x="6071792" y="4498394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M44PE </a:t>
            </a:r>
            <a:r>
              <a:rPr lang="en-US" sz="1200" b="1" dirty="0" err="1"/>
              <a:t>TamR</a:t>
            </a:r>
            <a:r>
              <a:rPr lang="en-US" sz="1200" b="1" dirty="0"/>
              <a:t> 500</a:t>
            </a:r>
          </a:p>
        </p:txBody>
      </p:sp>
      <p:sp>
        <p:nvSpPr>
          <p:cNvPr id="25" name="TextBox 24"/>
          <p:cNvSpPr txBox="1"/>
          <p:nvPr/>
        </p:nvSpPr>
        <p:spPr>
          <a:xfrm rot="3276555">
            <a:off x="6435946" y="4507040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M44PE LTED A</a:t>
            </a:r>
          </a:p>
        </p:txBody>
      </p:sp>
      <p:sp>
        <p:nvSpPr>
          <p:cNvPr id="26" name="TextBox 25"/>
          <p:cNvSpPr txBox="1"/>
          <p:nvPr/>
        </p:nvSpPr>
        <p:spPr>
          <a:xfrm rot="3276555">
            <a:off x="6800100" y="4515687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M44PE LTED B</a:t>
            </a:r>
          </a:p>
        </p:txBody>
      </p:sp>
      <p:sp>
        <p:nvSpPr>
          <p:cNvPr id="27" name="TextBox 26"/>
          <p:cNvSpPr txBox="1"/>
          <p:nvPr/>
        </p:nvSpPr>
        <p:spPr>
          <a:xfrm rot="3276555">
            <a:off x="7164255" y="4527397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T474</a:t>
            </a:r>
          </a:p>
        </p:txBody>
      </p:sp>
      <p:sp>
        <p:nvSpPr>
          <p:cNvPr id="28" name="TextBox 27"/>
          <p:cNvSpPr txBox="1"/>
          <p:nvPr/>
        </p:nvSpPr>
        <p:spPr>
          <a:xfrm rot="3276555">
            <a:off x="7583517" y="4539107"/>
            <a:ext cx="1752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47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897F828-E994-70A0-A8D2-F61AAAABDC4C}"/>
              </a:ext>
            </a:extLst>
          </p:cNvPr>
          <p:cNvSpPr txBox="1"/>
          <p:nvPr/>
        </p:nvSpPr>
        <p:spPr>
          <a:xfrm>
            <a:off x="85725" y="252469"/>
            <a:ext cx="177804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.E</a:t>
            </a:r>
            <a:r>
              <a:rPr lang="en-US" sz="1200" dirty="0"/>
              <a:t>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riginal western blot</a:t>
            </a:r>
            <a:endParaRPr lang="en-US" sz="1200" dirty="0"/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58915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3F5E7F4-387C-7B91-CD31-7CD14E300650}"/>
              </a:ext>
            </a:extLst>
          </p:cNvPr>
          <p:cNvSpPr txBox="1"/>
          <p:nvPr/>
        </p:nvSpPr>
        <p:spPr>
          <a:xfrm>
            <a:off x="196559" y="317168"/>
            <a:ext cx="32930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4C</a:t>
            </a:r>
            <a:r>
              <a:rPr lang="en-US" sz="1600" dirty="0"/>
              <a:t>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 original W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ern blot</a:t>
            </a:r>
            <a:endParaRPr lang="en-US" sz="1600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0E6C5F75-7860-059F-C04F-C37BCD983777}"/>
              </a:ext>
            </a:extLst>
          </p:cNvPr>
          <p:cNvGrpSpPr/>
          <p:nvPr/>
        </p:nvGrpSpPr>
        <p:grpSpPr>
          <a:xfrm>
            <a:off x="597233" y="849401"/>
            <a:ext cx="3286100" cy="2018465"/>
            <a:chOff x="422448" y="757398"/>
            <a:chExt cx="3286100" cy="2018465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BE09166-CCD8-EA9B-10BA-C795872046D6}"/>
                </a:ext>
              </a:extLst>
            </p:cNvPr>
            <p:cNvSpPr txBox="1"/>
            <p:nvPr/>
          </p:nvSpPr>
          <p:spPr>
            <a:xfrm>
              <a:off x="422448" y="1633404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50K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5F72FC0-4F72-B92C-8851-C66751D0D7BE}"/>
                </a:ext>
              </a:extLst>
            </p:cNvPr>
            <p:cNvSpPr txBox="1"/>
            <p:nvPr/>
          </p:nvSpPr>
          <p:spPr>
            <a:xfrm>
              <a:off x="430526" y="1811794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37KD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81DCC81C-58B2-F10B-334F-B7F2F3A8AFDA}"/>
                </a:ext>
              </a:extLst>
            </p:cNvPr>
            <p:cNvGrpSpPr/>
            <p:nvPr/>
          </p:nvGrpSpPr>
          <p:grpSpPr>
            <a:xfrm>
              <a:off x="853554" y="757398"/>
              <a:ext cx="2854994" cy="2018465"/>
              <a:chOff x="853554" y="757398"/>
              <a:chExt cx="2854994" cy="2018465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D80D0146-7D00-390E-65F0-F6359C258954}"/>
                  </a:ext>
                </a:extLst>
              </p:cNvPr>
              <p:cNvSpPr txBox="1"/>
              <p:nvPr/>
            </p:nvSpPr>
            <p:spPr>
              <a:xfrm rot="16200000">
                <a:off x="913718" y="1296209"/>
                <a:ext cx="5469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134-P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552DB0F-AB7A-8D42-B811-B75B011750C8}"/>
                  </a:ext>
                </a:extLst>
              </p:cNvPr>
              <p:cNvSpPr txBox="1"/>
              <p:nvPr/>
            </p:nvSpPr>
            <p:spPr>
              <a:xfrm rot="16200000">
                <a:off x="2043967" y="1346719"/>
                <a:ext cx="6126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SUM-P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706E24E-6D2F-229F-E9D7-CA6AAE0EC34C}"/>
                  </a:ext>
                </a:extLst>
              </p:cNvPr>
              <p:cNvSpPr txBox="1"/>
              <p:nvPr/>
            </p:nvSpPr>
            <p:spPr>
              <a:xfrm rot="16200000">
                <a:off x="1038536" y="1296209"/>
                <a:ext cx="8346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134-TAMR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2EE7F18-07CF-FCD4-0891-F4723C66D59B}"/>
                  </a:ext>
                </a:extLst>
              </p:cNvPr>
              <p:cNvSpPr txBox="1"/>
              <p:nvPr/>
            </p:nvSpPr>
            <p:spPr>
              <a:xfrm rot="16200000">
                <a:off x="1219745" y="1228247"/>
                <a:ext cx="9011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134-LTED-A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4F8D9576-5FCC-832C-1595-3DD2E29966B1}"/>
                  </a:ext>
                </a:extLst>
              </p:cNvPr>
              <p:cNvSpPr txBox="1"/>
              <p:nvPr/>
            </p:nvSpPr>
            <p:spPr>
              <a:xfrm rot="16200000">
                <a:off x="1461938" y="1220317"/>
                <a:ext cx="9059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134-LTED-D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B700C79-7DAA-252B-98B7-870E8AA5B143}"/>
                  </a:ext>
                </a:extLst>
              </p:cNvPr>
              <p:cNvSpPr txBox="1"/>
              <p:nvPr/>
            </p:nvSpPr>
            <p:spPr>
              <a:xfrm rot="16200000">
                <a:off x="1699192" y="1216769"/>
                <a:ext cx="8867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134-LTED-E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18A095F-247A-AB3A-9E86-31FB8E0F44ED}"/>
                  </a:ext>
                </a:extLst>
              </p:cNvPr>
              <p:cNvSpPr txBox="1"/>
              <p:nvPr/>
            </p:nvSpPr>
            <p:spPr>
              <a:xfrm rot="16200000">
                <a:off x="2313829" y="1245638"/>
                <a:ext cx="9668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SUM-LTED-A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5348F0BD-2293-8545-8F01-F9E53C775C31}"/>
                  </a:ext>
                </a:extLst>
              </p:cNvPr>
              <p:cNvSpPr txBox="1"/>
              <p:nvPr/>
            </p:nvSpPr>
            <p:spPr>
              <a:xfrm rot="16200000">
                <a:off x="2521579" y="1242302"/>
                <a:ext cx="9668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SUM-LTED-B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293A4A7-8522-50E7-D25D-6B4D6CBB305E}"/>
                  </a:ext>
                </a:extLst>
              </p:cNvPr>
              <p:cNvSpPr txBox="1"/>
              <p:nvPr/>
            </p:nvSpPr>
            <p:spPr>
              <a:xfrm rot="16200000">
                <a:off x="2137977" y="1228246"/>
                <a:ext cx="9003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SUM-TAMR</a:t>
                </a:r>
              </a:p>
            </p:txBody>
          </p: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7C03A042-B075-5CF4-8FFB-3FDE9E72502D}"/>
                  </a:ext>
                </a:extLst>
              </p:cNvPr>
              <p:cNvGrpSpPr/>
              <p:nvPr/>
            </p:nvGrpSpPr>
            <p:grpSpPr>
              <a:xfrm>
                <a:off x="853554" y="757398"/>
                <a:ext cx="2854994" cy="2018465"/>
                <a:chOff x="3338747" y="658883"/>
                <a:chExt cx="2854994" cy="2018465"/>
              </a:xfrm>
            </p:grpSpPr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27281DBD-8A5E-C319-3ED9-D9E3D69F861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338747" y="658883"/>
                  <a:ext cx="2854994" cy="2018465"/>
                </a:xfrm>
                <a:prstGeom prst="rect">
                  <a:avLst/>
                </a:prstGeom>
              </p:spPr>
            </p:pic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90E77E15-54E6-43BA-180C-12703BC5279B}"/>
                    </a:ext>
                  </a:extLst>
                </p:cNvPr>
                <p:cNvSpPr txBox="1"/>
                <p:nvPr/>
              </p:nvSpPr>
              <p:spPr>
                <a:xfrm rot="16200000">
                  <a:off x="3607728" y="1368569"/>
                  <a:ext cx="2728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P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9AE901AE-9B20-1752-466A-86F4524EE87B}"/>
                    </a:ext>
                  </a:extLst>
                </p:cNvPr>
                <p:cNvSpPr txBox="1"/>
                <p:nvPr/>
              </p:nvSpPr>
              <p:spPr>
                <a:xfrm rot="16200000">
                  <a:off x="4881829" y="1346718"/>
                  <a:ext cx="2728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P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37103F94-065C-278F-CBC1-5FF43E025395}"/>
                    </a:ext>
                  </a:extLst>
                </p:cNvPr>
                <p:cNvSpPr txBox="1"/>
                <p:nvPr/>
              </p:nvSpPr>
              <p:spPr>
                <a:xfrm rot="16200000">
                  <a:off x="3725707" y="1328291"/>
                  <a:ext cx="55752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TAMR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3DA51A53-7A78-D752-AF22-5143667A828A}"/>
                    </a:ext>
                  </a:extLst>
                </p:cNvPr>
                <p:cNvSpPr txBox="1"/>
                <p:nvPr/>
              </p:nvSpPr>
              <p:spPr>
                <a:xfrm rot="16200000">
                  <a:off x="3965473" y="1307802"/>
                  <a:ext cx="60503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LTEDA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DC4961CE-60E5-D86F-E160-E7381A798ED7}"/>
                    </a:ext>
                  </a:extLst>
                </p:cNvPr>
                <p:cNvSpPr txBox="1"/>
                <p:nvPr/>
              </p:nvSpPr>
              <p:spPr>
                <a:xfrm rot="16200000">
                  <a:off x="4163771" y="1304261"/>
                  <a:ext cx="6738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  LTEDB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EEBD3D87-2D04-7F06-FD57-64FA81BC4E08}"/>
                    </a:ext>
                  </a:extLst>
                </p:cNvPr>
                <p:cNvSpPr txBox="1"/>
                <p:nvPr/>
              </p:nvSpPr>
              <p:spPr>
                <a:xfrm rot="16200000">
                  <a:off x="4439596" y="1275487"/>
                  <a:ext cx="6017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LTEDE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960F4605-6C58-F92B-9EC1-70A74A391AFD}"/>
                    </a:ext>
                  </a:extLst>
                </p:cNvPr>
                <p:cNvSpPr txBox="1"/>
                <p:nvPr/>
              </p:nvSpPr>
              <p:spPr>
                <a:xfrm rot="16200000">
                  <a:off x="5188087" y="1267163"/>
                  <a:ext cx="60503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LTEDA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2F532046-F520-2585-5170-9348A3B02DDC}"/>
                    </a:ext>
                  </a:extLst>
                </p:cNvPr>
                <p:cNvSpPr txBox="1"/>
                <p:nvPr/>
              </p:nvSpPr>
              <p:spPr>
                <a:xfrm rot="16200000">
                  <a:off x="5429585" y="1275488"/>
                  <a:ext cx="6097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LTEDB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2EF76342-0E1C-AC20-FBA7-5B513FA60295}"/>
                    </a:ext>
                  </a:extLst>
                </p:cNvPr>
                <p:cNvSpPr txBox="1"/>
                <p:nvPr/>
              </p:nvSpPr>
              <p:spPr>
                <a:xfrm rot="16200000">
                  <a:off x="4976063" y="1296208"/>
                  <a:ext cx="55752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TAMR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8D15627-51C9-8226-FF46-F8757A160F86}"/>
                    </a:ext>
                  </a:extLst>
                </p:cNvPr>
                <p:cNvSpPr txBox="1"/>
                <p:nvPr/>
              </p:nvSpPr>
              <p:spPr>
                <a:xfrm>
                  <a:off x="3953599" y="845912"/>
                  <a:ext cx="184642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B134                          SUM44</a:t>
                  </a:r>
                </a:p>
              </p:txBody>
            </p: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C1963213-87A4-5368-65B4-1F660C48B641}"/>
                    </a:ext>
                  </a:extLst>
                </p:cNvPr>
                <p:cNvCxnSpPr/>
                <p:nvPr/>
              </p:nvCxnSpPr>
              <p:spPr>
                <a:xfrm>
                  <a:off x="3744144" y="1076744"/>
                  <a:ext cx="1022100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DCB88183-13A6-A4C4-3FC7-B6F8A53087B1}"/>
                    </a:ext>
                  </a:extLst>
                </p:cNvPr>
                <p:cNvCxnSpPr/>
                <p:nvPr/>
              </p:nvCxnSpPr>
              <p:spPr>
                <a:xfrm>
                  <a:off x="4979555" y="1089736"/>
                  <a:ext cx="1022100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5AF844B9-25AE-F24C-8549-0CA4E25CF22A}"/>
              </a:ext>
            </a:extLst>
          </p:cNvPr>
          <p:cNvGrpSpPr/>
          <p:nvPr/>
        </p:nvGrpSpPr>
        <p:grpSpPr>
          <a:xfrm>
            <a:off x="7022686" y="878605"/>
            <a:ext cx="3526123" cy="1867094"/>
            <a:chOff x="6281435" y="757398"/>
            <a:chExt cx="3526123" cy="1867094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8A86DFAC-7363-50AA-0A04-C97261CCFA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85900" y="757398"/>
              <a:ext cx="3021658" cy="1867094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3FEBC8F-4729-9C57-E8A7-C8D520C13DE3}"/>
                </a:ext>
              </a:extLst>
            </p:cNvPr>
            <p:cNvSpPr txBox="1"/>
            <p:nvPr/>
          </p:nvSpPr>
          <p:spPr>
            <a:xfrm>
              <a:off x="7157096" y="1219264"/>
              <a:ext cx="20865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h    120h    0h    120h 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3008D71-E184-9B2A-C2A3-92ACBB0D6A6E}"/>
                </a:ext>
              </a:extLst>
            </p:cNvPr>
            <p:cNvSpPr txBox="1"/>
            <p:nvPr/>
          </p:nvSpPr>
          <p:spPr>
            <a:xfrm>
              <a:off x="7157096" y="810708"/>
              <a:ext cx="1182116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B134       SUM44</a:t>
              </a:r>
            </a:p>
            <a:p>
              <a:pPr>
                <a:lnSpc>
                  <a:spcPts val="900"/>
                </a:lnSpc>
              </a:pPr>
              <a:r>
                <a:rPr 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AMR        TAMR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8FD6F09-B222-0C81-259D-23B684DE249A}"/>
                </a:ext>
              </a:extLst>
            </p:cNvPr>
            <p:cNvSpPr txBox="1"/>
            <p:nvPr/>
          </p:nvSpPr>
          <p:spPr>
            <a:xfrm>
              <a:off x="6403779" y="1326986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SS1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358E2D8-833A-7BC0-E8F5-506638C3F3B9}"/>
                </a:ext>
              </a:extLst>
            </p:cNvPr>
            <p:cNvSpPr txBox="1"/>
            <p:nvPr/>
          </p:nvSpPr>
          <p:spPr>
            <a:xfrm>
              <a:off x="6281435" y="1566321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05DDF51-4CA6-1CB0-FB43-86567C8C4640}"/>
                </a:ext>
              </a:extLst>
            </p:cNvPr>
            <p:cNvSpPr txBox="1"/>
            <p:nvPr/>
          </p:nvSpPr>
          <p:spPr>
            <a:xfrm>
              <a:off x="8571645" y="775034"/>
              <a:ext cx="101186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 dAzaC (5µM) 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9DEA81AF-539F-6E71-CACD-8C7D0E4E54F3}"/>
                </a:ext>
              </a:extLst>
            </p:cNvPr>
            <p:cNvCxnSpPr/>
            <p:nvPr/>
          </p:nvCxnSpPr>
          <p:spPr>
            <a:xfrm>
              <a:off x="7251192" y="1188028"/>
              <a:ext cx="41148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3371C558-B4E9-D520-BE06-1F501E0D33CF}"/>
                </a:ext>
              </a:extLst>
            </p:cNvPr>
            <p:cNvCxnSpPr>
              <a:cxnSpLocks/>
            </p:cNvCxnSpPr>
            <p:nvPr/>
          </p:nvCxnSpPr>
          <p:spPr>
            <a:xfrm>
              <a:off x="7854696" y="1200976"/>
              <a:ext cx="345674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721D23F5-B988-C228-A381-4BF9F1CCC5EE}"/>
              </a:ext>
            </a:extLst>
          </p:cNvPr>
          <p:cNvGrpSpPr/>
          <p:nvPr/>
        </p:nvGrpSpPr>
        <p:grpSpPr>
          <a:xfrm>
            <a:off x="437606" y="4113170"/>
            <a:ext cx="3378388" cy="851609"/>
            <a:chOff x="236369" y="4024279"/>
            <a:chExt cx="3378388" cy="851609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C35DCE1-A901-C17C-D53E-56F0405F2C60}"/>
                </a:ext>
              </a:extLst>
            </p:cNvPr>
            <p:cNvSpPr txBox="1"/>
            <p:nvPr/>
          </p:nvSpPr>
          <p:spPr>
            <a:xfrm>
              <a:off x="1077673" y="4024279"/>
              <a:ext cx="25370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UM44               MB134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C582285-37E1-8B22-C478-E0622822BDE3}"/>
                </a:ext>
              </a:extLst>
            </p:cNvPr>
            <p:cNvSpPr txBox="1"/>
            <p:nvPr/>
          </p:nvSpPr>
          <p:spPr>
            <a:xfrm>
              <a:off x="930992" y="4176644"/>
              <a:ext cx="19511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LKO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hASS1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LKO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hASS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35E5C12-349C-5096-7416-760E7BD42F25}"/>
                </a:ext>
              </a:extLst>
            </p:cNvPr>
            <p:cNvSpPr txBox="1"/>
            <p:nvPr/>
          </p:nvSpPr>
          <p:spPr>
            <a:xfrm>
              <a:off x="236369" y="4645056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657277E-F1ED-788B-126C-DF27C617941C}"/>
                </a:ext>
              </a:extLst>
            </p:cNvPr>
            <p:cNvSpPr txBox="1"/>
            <p:nvPr/>
          </p:nvSpPr>
          <p:spPr>
            <a:xfrm>
              <a:off x="335819" y="4431939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SS1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BDC28513-7D60-8E92-8C59-077285784369}"/>
                </a:ext>
              </a:extLst>
            </p:cNvPr>
            <p:cNvCxnSpPr>
              <a:cxnSpLocks/>
            </p:cNvCxnSpPr>
            <p:nvPr/>
          </p:nvCxnSpPr>
          <p:spPr>
            <a:xfrm>
              <a:off x="1078134" y="4198660"/>
              <a:ext cx="6213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5A393A41-2218-BA9F-4AF5-2C929A88D5DE}"/>
                </a:ext>
              </a:extLst>
            </p:cNvPr>
            <p:cNvCxnSpPr>
              <a:cxnSpLocks/>
            </p:cNvCxnSpPr>
            <p:nvPr/>
          </p:nvCxnSpPr>
          <p:spPr>
            <a:xfrm>
              <a:off x="1917134" y="4198660"/>
              <a:ext cx="61482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624C1DD3-E05D-09C9-CE58-AEDB237F4F48}"/>
              </a:ext>
            </a:extLst>
          </p:cNvPr>
          <p:cNvGrpSpPr/>
          <p:nvPr/>
        </p:nvGrpSpPr>
        <p:grpSpPr>
          <a:xfrm>
            <a:off x="6874817" y="4113170"/>
            <a:ext cx="2646731" cy="2189106"/>
            <a:chOff x="6281435" y="3693200"/>
            <a:chExt cx="2646731" cy="2189106"/>
          </a:xfrm>
        </p:grpSpPr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4867D6F9-C9A9-91A3-CE21-0619E18428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208" t="35217" r="74051" b="46264"/>
            <a:stretch/>
          </p:blipFill>
          <p:spPr>
            <a:xfrm>
              <a:off x="6785900" y="3872808"/>
              <a:ext cx="2139573" cy="1086174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153A4457-348A-C306-0C98-6C71DF0921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54" t="19346" r="60043" b="64070"/>
            <a:stretch/>
          </p:blipFill>
          <p:spPr>
            <a:xfrm>
              <a:off x="6786491" y="4981117"/>
              <a:ext cx="2139573" cy="517639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5B6F6C01-B3CA-72B4-625D-A1DD7611B9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8691" r="74396" b="59062"/>
            <a:stretch/>
          </p:blipFill>
          <p:spPr>
            <a:xfrm>
              <a:off x="6785900" y="5498756"/>
              <a:ext cx="1068796" cy="382905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F7D51D8-895F-670F-2014-D51C355E00F7}"/>
                </a:ext>
              </a:extLst>
            </p:cNvPr>
            <p:cNvSpPr txBox="1"/>
            <p:nvPr/>
          </p:nvSpPr>
          <p:spPr>
            <a:xfrm>
              <a:off x="6364510" y="4214980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CA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F7E42FD-95F0-27CA-523A-BC560BDD091B}"/>
                </a:ext>
              </a:extLst>
            </p:cNvPr>
            <p:cNvSpPr txBox="1"/>
            <p:nvPr/>
          </p:nvSpPr>
          <p:spPr>
            <a:xfrm>
              <a:off x="6281435" y="5498756"/>
              <a:ext cx="397387" cy="133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72A8F88B-D976-221C-4747-C4453B977D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43950" r="74396" b="39599"/>
            <a:stretch/>
          </p:blipFill>
          <p:spPr>
            <a:xfrm>
              <a:off x="7859725" y="5498756"/>
              <a:ext cx="1068441" cy="383550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CA658BE-9C0D-1635-94B9-0AD3FB666F21}"/>
                </a:ext>
              </a:extLst>
            </p:cNvPr>
            <p:cNvSpPr txBox="1"/>
            <p:nvPr/>
          </p:nvSpPr>
          <p:spPr>
            <a:xfrm>
              <a:off x="6403779" y="5157927"/>
              <a:ext cx="289704" cy="133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D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757DED6-7666-92D5-2C74-3B4EE00A953F}"/>
                </a:ext>
              </a:extLst>
            </p:cNvPr>
            <p:cNvSpPr txBox="1"/>
            <p:nvPr/>
          </p:nvSpPr>
          <p:spPr>
            <a:xfrm rot="16200000">
              <a:off x="6933561" y="4056530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TAMR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913151A-9F25-D662-3EF5-6ED6DAA49BB4}"/>
                </a:ext>
              </a:extLst>
            </p:cNvPr>
            <p:cNvSpPr txBox="1"/>
            <p:nvPr/>
          </p:nvSpPr>
          <p:spPr>
            <a:xfrm rot="16200000">
              <a:off x="6855608" y="4025758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B242EAD-5508-652F-2D4B-B82B69BD7FCA}"/>
                </a:ext>
              </a:extLst>
            </p:cNvPr>
            <p:cNvSpPr txBox="1"/>
            <p:nvPr/>
          </p:nvSpPr>
          <p:spPr>
            <a:xfrm rot="16200000">
              <a:off x="7300994" y="4073352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TAMR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2B6AE8C-3137-AA5D-BB53-DCD6454F6356}"/>
                </a:ext>
              </a:extLst>
            </p:cNvPr>
            <p:cNvSpPr txBox="1"/>
            <p:nvPr/>
          </p:nvSpPr>
          <p:spPr>
            <a:xfrm rot="16200000">
              <a:off x="7223041" y="4042580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60C3DA8-D364-C4A6-A9D2-A52B8729B3D8}"/>
                </a:ext>
              </a:extLst>
            </p:cNvPr>
            <p:cNvSpPr txBox="1"/>
            <p:nvPr/>
          </p:nvSpPr>
          <p:spPr>
            <a:xfrm rot="16200000">
              <a:off x="7892240" y="4009202"/>
              <a:ext cx="4860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sh</a:t>
              </a:r>
              <a:r>
                <a:rPr lang="en-US" sz="800" dirty="0"/>
                <a:t>RNA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D76F835-7537-BFC8-0E4F-A1A1503DEBF4}"/>
                </a:ext>
              </a:extLst>
            </p:cNvPr>
            <p:cNvSpPr txBox="1"/>
            <p:nvPr/>
          </p:nvSpPr>
          <p:spPr>
            <a:xfrm rot="16200000">
              <a:off x="8199513" y="4018391"/>
              <a:ext cx="4860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sh</a:t>
              </a:r>
              <a:r>
                <a:rPr lang="en-US" sz="800" dirty="0"/>
                <a:t>RNA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FCEBB30-59AB-C97E-D88C-53D3556BC95F}"/>
                </a:ext>
              </a:extLst>
            </p:cNvPr>
            <p:cNvSpPr txBox="1"/>
            <p:nvPr/>
          </p:nvSpPr>
          <p:spPr>
            <a:xfrm>
              <a:off x="6802253" y="3693200"/>
              <a:ext cx="9124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B134  SUM44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FE77EAA-49A8-2D44-3FF8-110F3CBF4325}"/>
                </a:ext>
              </a:extLst>
            </p:cNvPr>
            <p:cNvSpPr txBox="1"/>
            <p:nvPr/>
          </p:nvSpPr>
          <p:spPr>
            <a:xfrm>
              <a:off x="7759666" y="3712844"/>
              <a:ext cx="9124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B134  SUM44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3AF63BAC-BA43-38B4-21E9-A2AB6F073DC7}"/>
                </a:ext>
              </a:extLst>
            </p:cNvPr>
            <p:cNvSpPr txBox="1"/>
            <p:nvPr/>
          </p:nvSpPr>
          <p:spPr>
            <a:xfrm rot="16200000">
              <a:off x="7744391" y="4025757"/>
              <a:ext cx="4267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/>
                <a:t>pLKO</a:t>
              </a:r>
              <a:endParaRPr lang="en-US" sz="800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2564EB3-5968-D985-E635-45E027230C7E}"/>
                </a:ext>
              </a:extLst>
            </p:cNvPr>
            <p:cNvSpPr txBox="1"/>
            <p:nvPr/>
          </p:nvSpPr>
          <p:spPr>
            <a:xfrm rot="16200000">
              <a:off x="8048584" y="4033926"/>
              <a:ext cx="4267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/>
                <a:t>pLKO</a:t>
              </a:r>
              <a:endParaRPr lang="en-US" sz="800" dirty="0"/>
            </a:p>
          </p:txBody>
        </p:sp>
      </p:grpSp>
      <p:pic>
        <p:nvPicPr>
          <p:cNvPr id="69" name="Picture 68">
            <a:extLst>
              <a:ext uri="{FF2B5EF4-FFF2-40B4-BE49-F238E27FC236}">
                <a16:creationId xmlns:a16="http://schemas.microsoft.com/office/drawing/2014/main" id="{CDB7BD73-01E0-57F3-187E-C33238704DF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297" r="12113"/>
          <a:stretch/>
        </p:blipFill>
        <p:spPr>
          <a:xfrm>
            <a:off x="980240" y="4447949"/>
            <a:ext cx="1885441" cy="870732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1707E23A-F54D-622C-02EC-41BA5E8F9C2C}"/>
              </a:ext>
            </a:extLst>
          </p:cNvPr>
          <p:cNvSpPr txBox="1"/>
          <p:nvPr/>
        </p:nvSpPr>
        <p:spPr>
          <a:xfrm>
            <a:off x="7463256" y="389774"/>
            <a:ext cx="32930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4G</a:t>
            </a:r>
            <a:r>
              <a:rPr lang="en-US" sz="1600" dirty="0"/>
              <a:t>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 original W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ern blot</a:t>
            </a:r>
            <a:endParaRPr lang="en-US" sz="16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3694DBD-8137-5BA2-409C-C73DE833F19D}"/>
              </a:ext>
            </a:extLst>
          </p:cNvPr>
          <p:cNvSpPr txBox="1"/>
          <p:nvPr/>
        </p:nvSpPr>
        <p:spPr>
          <a:xfrm>
            <a:off x="276431" y="3656225"/>
            <a:ext cx="32930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5B</a:t>
            </a:r>
            <a:r>
              <a:rPr lang="en-US" sz="1600" dirty="0"/>
              <a:t>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 original W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ern blot</a:t>
            </a:r>
            <a:endParaRPr lang="en-US" sz="16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E6D4093-2E25-C42E-3D1E-9D90F8A0F2D3}"/>
              </a:ext>
            </a:extLst>
          </p:cNvPr>
          <p:cNvSpPr txBox="1"/>
          <p:nvPr/>
        </p:nvSpPr>
        <p:spPr>
          <a:xfrm>
            <a:off x="6842876" y="3594272"/>
            <a:ext cx="32930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6J</a:t>
            </a:r>
            <a:r>
              <a:rPr lang="en-US" sz="1600" dirty="0"/>
              <a:t>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 original W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ern blot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0414593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2BA5272-692D-EE35-9665-55D8D05B6A5F}"/>
              </a:ext>
            </a:extLst>
          </p:cNvPr>
          <p:cNvSpPr txBox="1"/>
          <p:nvPr/>
        </p:nvSpPr>
        <p:spPr>
          <a:xfrm>
            <a:off x="196559" y="317168"/>
            <a:ext cx="35703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4E</a:t>
            </a:r>
            <a:r>
              <a:rPr lang="en-US" sz="1600" dirty="0"/>
              <a:t>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NA electrophoresis gel </a:t>
            </a:r>
            <a:endParaRPr lang="en-US" sz="1600" dirty="0"/>
          </a:p>
          <a:p>
            <a:pPr algn="just"/>
            <a:endParaRPr lang="en-US" sz="1600" dirty="0"/>
          </a:p>
        </p:txBody>
      </p:sp>
      <p:pic>
        <p:nvPicPr>
          <p:cNvPr id="3" name="Picture 2" descr="A close-up of a plastic sheet&#10;&#10;Description automatically generated">
            <a:extLst>
              <a:ext uri="{FF2B5EF4-FFF2-40B4-BE49-F238E27FC236}">
                <a16:creationId xmlns:a16="http://schemas.microsoft.com/office/drawing/2014/main" id="{C9E4D0F2-D76A-C57C-DCD9-0092A5F50AD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04" t="22313" r="42141" b="45278"/>
          <a:stretch/>
        </p:blipFill>
        <p:spPr>
          <a:xfrm>
            <a:off x="734164" y="1481816"/>
            <a:ext cx="2028506" cy="205195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97E80DE-426B-1FB3-B68B-AD7FFA982572}"/>
              </a:ext>
            </a:extLst>
          </p:cNvPr>
          <p:cNvSpPr txBox="1"/>
          <p:nvPr/>
        </p:nvSpPr>
        <p:spPr>
          <a:xfrm rot="16200000">
            <a:off x="1164927" y="2444286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P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8A49C4-2D27-6D2A-1345-B69525872318}"/>
              </a:ext>
            </a:extLst>
          </p:cNvPr>
          <p:cNvSpPr txBox="1"/>
          <p:nvPr/>
        </p:nvSpPr>
        <p:spPr>
          <a:xfrm rot="16200000">
            <a:off x="1385272" y="2425733"/>
            <a:ext cx="5575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TAM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375B34-5848-7890-23FE-3260FBBEBEAA}"/>
              </a:ext>
            </a:extLst>
          </p:cNvPr>
          <p:cNvSpPr txBox="1"/>
          <p:nvPr/>
        </p:nvSpPr>
        <p:spPr>
          <a:xfrm rot="16200000">
            <a:off x="1652223" y="2444287"/>
            <a:ext cx="6050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LTE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BA1618-7419-E9BE-B55E-455F6001B52F}"/>
              </a:ext>
            </a:extLst>
          </p:cNvPr>
          <p:cNvSpPr txBox="1"/>
          <p:nvPr/>
        </p:nvSpPr>
        <p:spPr>
          <a:xfrm rot="16200000">
            <a:off x="1980514" y="2454436"/>
            <a:ext cx="67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  LTED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85F37A-0A36-C0C5-D0CF-A014207D98DB}"/>
              </a:ext>
            </a:extLst>
          </p:cNvPr>
          <p:cNvSpPr txBox="1"/>
          <p:nvPr/>
        </p:nvSpPr>
        <p:spPr>
          <a:xfrm>
            <a:off x="287362" y="2813997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b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3A58BB-7635-F6C3-29A1-E453FFDB231B}"/>
              </a:ext>
            </a:extLst>
          </p:cNvPr>
          <p:cNvSpPr txBox="1"/>
          <p:nvPr/>
        </p:nvSpPr>
        <p:spPr>
          <a:xfrm>
            <a:off x="1410521" y="1733614"/>
            <a:ext cx="8114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pG Primer</a:t>
            </a:r>
          </a:p>
        </p:txBody>
      </p:sp>
      <p:pic>
        <p:nvPicPr>
          <p:cNvPr id="10" name="Picture 9" descr="A close-up of a film&#10;&#10;Description automatically generated">
            <a:extLst>
              <a:ext uri="{FF2B5EF4-FFF2-40B4-BE49-F238E27FC236}">
                <a16:creationId xmlns:a16="http://schemas.microsoft.com/office/drawing/2014/main" id="{87948675-8733-40C7-9F77-791A5C09A17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06" t="6841" r="48433" b="57436"/>
          <a:stretch/>
        </p:blipFill>
        <p:spPr>
          <a:xfrm>
            <a:off x="734164" y="3785573"/>
            <a:ext cx="2039137" cy="205195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F4501AC-8BF6-0B48-8755-38D4CEDDFD41}"/>
              </a:ext>
            </a:extLst>
          </p:cNvPr>
          <p:cNvSpPr txBox="1"/>
          <p:nvPr/>
        </p:nvSpPr>
        <p:spPr>
          <a:xfrm>
            <a:off x="287362" y="5452154"/>
            <a:ext cx="5446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47b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09AE74-51AF-BD88-5C58-2E1E3AA81C3E}"/>
              </a:ext>
            </a:extLst>
          </p:cNvPr>
          <p:cNvSpPr txBox="1"/>
          <p:nvPr/>
        </p:nvSpPr>
        <p:spPr>
          <a:xfrm>
            <a:off x="1450903" y="4194554"/>
            <a:ext cx="8195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 Prime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49087ED-8625-4EA2-A958-4E748241AC23}"/>
              </a:ext>
            </a:extLst>
          </p:cNvPr>
          <p:cNvSpPr txBox="1"/>
          <p:nvPr/>
        </p:nvSpPr>
        <p:spPr>
          <a:xfrm>
            <a:off x="1536225" y="4052092"/>
            <a:ext cx="6205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B13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508896-8D98-7740-F08F-19149AF8856E}"/>
              </a:ext>
            </a:extLst>
          </p:cNvPr>
          <p:cNvSpPr txBox="1"/>
          <p:nvPr/>
        </p:nvSpPr>
        <p:spPr>
          <a:xfrm>
            <a:off x="1525535" y="1596017"/>
            <a:ext cx="6205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B13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EDFBD1-86DB-BA1D-A356-6F0A3551E98E}"/>
              </a:ext>
            </a:extLst>
          </p:cNvPr>
          <p:cNvSpPr txBox="1"/>
          <p:nvPr/>
        </p:nvSpPr>
        <p:spPr>
          <a:xfrm rot="16200000">
            <a:off x="1303426" y="4776414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B6DF960-1323-954F-0A7D-BF8472DF4E33}"/>
              </a:ext>
            </a:extLst>
          </p:cNvPr>
          <p:cNvSpPr txBox="1"/>
          <p:nvPr/>
        </p:nvSpPr>
        <p:spPr>
          <a:xfrm rot="16200000">
            <a:off x="1523771" y="4757861"/>
            <a:ext cx="5575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TAM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01081A0-8A77-7EED-598F-0AC33B1E7111}"/>
              </a:ext>
            </a:extLst>
          </p:cNvPr>
          <p:cNvSpPr txBox="1"/>
          <p:nvPr/>
        </p:nvSpPr>
        <p:spPr>
          <a:xfrm rot="16200000">
            <a:off x="1915418" y="4757860"/>
            <a:ext cx="6050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LTE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83DB5A2-55C5-1292-9C1E-108EBC49A5FD}"/>
              </a:ext>
            </a:extLst>
          </p:cNvPr>
          <p:cNvSpPr txBox="1"/>
          <p:nvPr/>
        </p:nvSpPr>
        <p:spPr>
          <a:xfrm rot="16200000">
            <a:off x="2227949" y="4798395"/>
            <a:ext cx="67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  LTEDB</a:t>
            </a:r>
          </a:p>
        </p:txBody>
      </p:sp>
      <p:pic>
        <p:nvPicPr>
          <p:cNvPr id="19" name="Picture 18" descr="A close-up of a film&#10;&#10;Description automatically generated">
            <a:extLst>
              <a:ext uri="{FF2B5EF4-FFF2-40B4-BE49-F238E27FC236}">
                <a16:creationId xmlns:a16="http://schemas.microsoft.com/office/drawing/2014/main" id="{EE929331-7104-1344-08F9-81863367E3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86" t="6112" r="48932" b="45502"/>
          <a:stretch/>
        </p:blipFill>
        <p:spPr>
          <a:xfrm>
            <a:off x="7094059" y="3514605"/>
            <a:ext cx="1697516" cy="185679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64F2523-7A7D-ED37-EA49-CC3CAB8BFC4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9125" r="42055" b="68250"/>
          <a:stretch/>
        </p:blipFill>
        <p:spPr>
          <a:xfrm>
            <a:off x="7094059" y="1366157"/>
            <a:ext cx="2228555" cy="1635399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5BE8B9D6-1AD5-60EC-879B-5639E6F0F316}"/>
              </a:ext>
            </a:extLst>
          </p:cNvPr>
          <p:cNvSpPr txBox="1"/>
          <p:nvPr/>
        </p:nvSpPr>
        <p:spPr>
          <a:xfrm>
            <a:off x="6659292" y="2679325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b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2004A63-F395-2514-38E0-7D466415B719}"/>
              </a:ext>
            </a:extLst>
          </p:cNvPr>
          <p:cNvSpPr txBox="1"/>
          <p:nvPr/>
        </p:nvSpPr>
        <p:spPr>
          <a:xfrm>
            <a:off x="6684409" y="4943709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47bp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D735ABE-B040-5A76-35F4-C79D6B9013CB}"/>
              </a:ext>
            </a:extLst>
          </p:cNvPr>
          <p:cNvSpPr txBox="1"/>
          <p:nvPr/>
        </p:nvSpPr>
        <p:spPr>
          <a:xfrm>
            <a:off x="7873818" y="1711433"/>
            <a:ext cx="8114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pG Prime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6433B9E-E907-F942-38DE-6E6339F54AB5}"/>
              </a:ext>
            </a:extLst>
          </p:cNvPr>
          <p:cNvSpPr txBox="1"/>
          <p:nvPr/>
        </p:nvSpPr>
        <p:spPr>
          <a:xfrm>
            <a:off x="7873818" y="3817002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 Prime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A587947-2884-5C86-7AC6-DDAF994649A6}"/>
              </a:ext>
            </a:extLst>
          </p:cNvPr>
          <p:cNvSpPr txBox="1"/>
          <p:nvPr/>
        </p:nvSpPr>
        <p:spPr>
          <a:xfrm>
            <a:off x="7942642" y="3660437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4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71B3588-C14E-AFA5-B0E7-3764E3E5B5C3}"/>
              </a:ext>
            </a:extLst>
          </p:cNvPr>
          <p:cNvSpPr txBox="1"/>
          <p:nvPr/>
        </p:nvSpPr>
        <p:spPr>
          <a:xfrm>
            <a:off x="7942642" y="1558312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4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6F9C371-D728-5642-21E1-ACAED7CF1552}"/>
              </a:ext>
            </a:extLst>
          </p:cNvPr>
          <p:cNvSpPr txBox="1"/>
          <p:nvPr/>
        </p:nvSpPr>
        <p:spPr>
          <a:xfrm rot="16200000">
            <a:off x="7586292" y="2225886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P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CDED318-CD9E-3235-98C3-794AB3673C92}"/>
              </a:ext>
            </a:extLst>
          </p:cNvPr>
          <p:cNvSpPr txBox="1"/>
          <p:nvPr/>
        </p:nvSpPr>
        <p:spPr>
          <a:xfrm rot="16200000">
            <a:off x="7806637" y="2207333"/>
            <a:ext cx="5575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TAM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D8F8B5F-60CD-81F6-071E-3708D9747DB8}"/>
              </a:ext>
            </a:extLst>
          </p:cNvPr>
          <p:cNvSpPr txBox="1"/>
          <p:nvPr/>
        </p:nvSpPr>
        <p:spPr>
          <a:xfrm rot="16200000">
            <a:off x="8151776" y="2218860"/>
            <a:ext cx="6050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LTE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FA31BA7-CE0E-BCA2-B108-9DE48F651B1C}"/>
              </a:ext>
            </a:extLst>
          </p:cNvPr>
          <p:cNvSpPr txBox="1"/>
          <p:nvPr/>
        </p:nvSpPr>
        <p:spPr>
          <a:xfrm rot="16200000">
            <a:off x="8486839" y="2236036"/>
            <a:ext cx="67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  LTED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70FF97C-F667-1B77-01F8-697ED07FC88A}"/>
              </a:ext>
            </a:extLst>
          </p:cNvPr>
          <p:cNvSpPr txBox="1"/>
          <p:nvPr/>
        </p:nvSpPr>
        <p:spPr>
          <a:xfrm rot="16200000">
            <a:off x="7493827" y="4374111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P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31A01DC-55A8-C529-CB9E-E7C8A01578D9}"/>
              </a:ext>
            </a:extLst>
          </p:cNvPr>
          <p:cNvSpPr txBox="1"/>
          <p:nvPr/>
        </p:nvSpPr>
        <p:spPr>
          <a:xfrm rot="16200000">
            <a:off x="7628480" y="4317547"/>
            <a:ext cx="5575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TAM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D8FA57C-EEE2-5B63-8E8C-06B71C9B3A32}"/>
              </a:ext>
            </a:extLst>
          </p:cNvPr>
          <p:cNvSpPr txBox="1"/>
          <p:nvPr/>
        </p:nvSpPr>
        <p:spPr>
          <a:xfrm rot="16200000">
            <a:off x="7838520" y="4271498"/>
            <a:ext cx="6050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LTE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A8881C9-E1C3-D0F6-BF1D-A333DE48349A}"/>
              </a:ext>
            </a:extLst>
          </p:cNvPr>
          <p:cNvSpPr txBox="1"/>
          <p:nvPr/>
        </p:nvSpPr>
        <p:spPr>
          <a:xfrm rot="16200000">
            <a:off x="8059589" y="4303078"/>
            <a:ext cx="67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  LTEDB</a:t>
            </a:r>
          </a:p>
        </p:txBody>
      </p:sp>
    </p:spTree>
    <p:extLst>
      <p:ext uri="{BB962C8B-B14F-4D97-AF65-F5344CB8AC3E}">
        <p14:creationId xmlns:p14="http://schemas.microsoft.com/office/powerpoint/2010/main" val="7441932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5BAA63-B207-52E9-5164-57C919862C4B}"/>
              </a:ext>
            </a:extLst>
          </p:cNvPr>
          <p:cNvSpPr txBox="1"/>
          <p:nvPr/>
        </p:nvSpPr>
        <p:spPr>
          <a:xfrm>
            <a:off x="196558" y="317168"/>
            <a:ext cx="72649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 S4: B. </a:t>
            </a:r>
            <a:r>
              <a:rPr lang="en-US" sz="1600" dirty="0"/>
              <a:t>O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riginal W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ern blot</a:t>
            </a:r>
            <a:endParaRPr lang="en-US" sz="1600" dirty="0"/>
          </a:p>
          <a:p>
            <a:pPr algn="just"/>
            <a:endParaRPr lang="en-US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DA696FC-F580-1DA6-3F62-E3934ED0959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58400" b="1051"/>
          <a:stretch/>
        </p:blipFill>
        <p:spPr>
          <a:xfrm>
            <a:off x="1141777" y="1099825"/>
            <a:ext cx="1890551" cy="2177439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BF2A738F-E5AD-5F82-93F4-C2AC4410C0E7}"/>
              </a:ext>
            </a:extLst>
          </p:cNvPr>
          <p:cNvGrpSpPr/>
          <p:nvPr/>
        </p:nvGrpSpPr>
        <p:grpSpPr>
          <a:xfrm>
            <a:off x="1448704" y="1383717"/>
            <a:ext cx="711369" cy="1197764"/>
            <a:chOff x="9733" y="-67414"/>
            <a:chExt cx="637588" cy="1045604"/>
          </a:xfrm>
        </p:grpSpPr>
        <p:sp>
          <p:nvSpPr>
            <p:cNvPr id="5" name="TextBox 8">
              <a:extLst>
                <a:ext uri="{FF2B5EF4-FFF2-40B4-BE49-F238E27FC236}">
                  <a16:creationId xmlns:a16="http://schemas.microsoft.com/office/drawing/2014/main" id="{F70E04AF-2F67-53A3-9BA1-B3D1B2E42406}"/>
                </a:ext>
              </a:extLst>
            </p:cNvPr>
            <p:cNvSpPr txBox="1"/>
            <p:nvPr/>
          </p:nvSpPr>
          <p:spPr>
            <a:xfrm rot="16200000">
              <a:off x="-304172" y="372618"/>
              <a:ext cx="862288" cy="234477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solidFill>
                    <a:schemeClr val="bg1"/>
                  </a:solidFill>
                </a:rPr>
                <a:t>MB134-pLKO</a:t>
              </a:r>
            </a:p>
          </p:txBody>
        </p:sp>
        <p:sp>
          <p:nvSpPr>
            <p:cNvPr id="6" name="TextBox 9">
              <a:extLst>
                <a:ext uri="{FF2B5EF4-FFF2-40B4-BE49-F238E27FC236}">
                  <a16:creationId xmlns:a16="http://schemas.microsoft.com/office/drawing/2014/main" id="{936330BF-4203-BF0C-43E3-F2206A635211}"/>
                </a:ext>
              </a:extLst>
            </p:cNvPr>
            <p:cNvSpPr txBox="1"/>
            <p:nvPr/>
          </p:nvSpPr>
          <p:spPr>
            <a:xfrm rot="16200000">
              <a:off x="7281" y="338149"/>
              <a:ext cx="1045604" cy="234477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solidFill>
                    <a:schemeClr val="bg1"/>
                  </a:solidFill>
                </a:rPr>
                <a:t>MB134-</a:t>
              </a:r>
              <a:r>
                <a:rPr lang="en-US" sz="1100" i="1" dirty="0">
                  <a:solidFill>
                    <a:schemeClr val="bg1"/>
                  </a:solidFill>
                </a:rPr>
                <a:t>shASS1</a:t>
              </a:r>
              <a:r>
                <a:rPr lang="en-US" sz="1100" dirty="0">
                  <a:solidFill>
                    <a:schemeClr val="bg1"/>
                  </a:solidFill>
                </a:rPr>
                <a:t>a</a:t>
              </a:r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2AAD92A6-26AA-8DB2-8985-97FD6CEFE84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62739"/>
          <a:stretch/>
        </p:blipFill>
        <p:spPr>
          <a:xfrm>
            <a:off x="1151047" y="3296237"/>
            <a:ext cx="1796279" cy="162900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1CE5745-9BE1-FFD2-2DEE-49508B1CDAF0}"/>
              </a:ext>
            </a:extLst>
          </p:cNvPr>
          <p:cNvSpPr txBox="1"/>
          <p:nvPr/>
        </p:nvSpPr>
        <p:spPr>
          <a:xfrm>
            <a:off x="1678746" y="1229469"/>
            <a:ext cx="740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  MB13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19BC3E-59C2-0955-6B33-94DD04EE39D3}"/>
              </a:ext>
            </a:extLst>
          </p:cNvPr>
          <p:cNvSpPr txBox="1"/>
          <p:nvPr/>
        </p:nvSpPr>
        <p:spPr>
          <a:xfrm>
            <a:off x="720762" y="2406169"/>
            <a:ext cx="4285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SS1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E3B02B8-7DC7-2D47-6F5A-DFD3A6431D18}"/>
              </a:ext>
            </a:extLst>
          </p:cNvPr>
          <p:cNvCxnSpPr>
            <a:cxnSpLocks/>
          </p:cNvCxnSpPr>
          <p:nvPr/>
        </p:nvCxnSpPr>
        <p:spPr>
          <a:xfrm>
            <a:off x="1487062" y="1442024"/>
            <a:ext cx="112425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E47340F-6BDB-3858-5D92-3BE59FE2FC19}"/>
              </a:ext>
            </a:extLst>
          </p:cNvPr>
          <p:cNvSpPr txBox="1"/>
          <p:nvPr/>
        </p:nvSpPr>
        <p:spPr>
          <a:xfrm>
            <a:off x="687210" y="4223464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5" name="TextBox 9">
            <a:extLst>
              <a:ext uri="{FF2B5EF4-FFF2-40B4-BE49-F238E27FC236}">
                <a16:creationId xmlns:a16="http://schemas.microsoft.com/office/drawing/2014/main" id="{F969E54F-C885-E374-02E7-033537C5B435}"/>
              </a:ext>
            </a:extLst>
          </p:cNvPr>
          <p:cNvSpPr txBox="1"/>
          <p:nvPr/>
        </p:nvSpPr>
        <p:spPr>
          <a:xfrm rot="16200000">
            <a:off x="1868119" y="1835075"/>
            <a:ext cx="1197764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solidFill>
                  <a:schemeClr val="bg1"/>
                </a:solidFill>
              </a:rPr>
              <a:t>MB134-</a:t>
            </a:r>
            <a:r>
              <a:rPr lang="en-US" sz="1100" i="1" dirty="0">
                <a:solidFill>
                  <a:schemeClr val="bg1"/>
                </a:solidFill>
              </a:rPr>
              <a:t>shASS1</a:t>
            </a:r>
            <a:r>
              <a:rPr lang="en-US" sz="1100" dirty="0">
                <a:solidFill>
                  <a:schemeClr val="bg1"/>
                </a:solidFill>
              </a:rPr>
              <a:t>a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13E4534-1CEB-B0C5-DEF8-FD61E1CA306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18249"/>
          <a:stretch/>
        </p:blipFill>
        <p:spPr>
          <a:xfrm>
            <a:off x="4040219" y="2790928"/>
            <a:ext cx="4635151" cy="175284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611553A-639F-F212-1A22-F4144EBA0C1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11686"/>
          <a:stretch/>
        </p:blipFill>
        <p:spPr>
          <a:xfrm>
            <a:off x="4040219" y="1099825"/>
            <a:ext cx="4635151" cy="1609950"/>
          </a:xfrm>
          <a:prstGeom prst="rect">
            <a:avLst/>
          </a:prstGeom>
        </p:spPr>
      </p:pic>
      <p:grpSp>
        <p:nvGrpSpPr>
          <p:cNvPr id="18" name="Group 17">
            <a:extLst>
              <a:ext uri="{FF2B5EF4-FFF2-40B4-BE49-F238E27FC236}">
                <a16:creationId xmlns:a16="http://schemas.microsoft.com/office/drawing/2014/main" id="{3AB72B23-5CC1-0090-5202-CC07B9C2B1AD}"/>
              </a:ext>
            </a:extLst>
          </p:cNvPr>
          <p:cNvGrpSpPr/>
          <p:nvPr/>
        </p:nvGrpSpPr>
        <p:grpSpPr>
          <a:xfrm>
            <a:off x="4335646" y="4429749"/>
            <a:ext cx="1614572" cy="1030356"/>
            <a:chOff x="17847" y="3887726"/>
            <a:chExt cx="1614572" cy="1030356"/>
          </a:xfrm>
        </p:grpSpPr>
        <p:sp>
          <p:nvSpPr>
            <p:cNvPr id="19" name="TextBox 6">
              <a:extLst>
                <a:ext uri="{FF2B5EF4-FFF2-40B4-BE49-F238E27FC236}">
                  <a16:creationId xmlns:a16="http://schemas.microsoft.com/office/drawing/2014/main" id="{0DE280E1-534D-C5D8-FABE-311471E46C93}"/>
                </a:ext>
              </a:extLst>
            </p:cNvPr>
            <p:cNvSpPr txBox="1"/>
            <p:nvPr/>
          </p:nvSpPr>
          <p:spPr>
            <a:xfrm rot="16200000">
              <a:off x="-346837" y="4252410"/>
              <a:ext cx="990977" cy="26161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MB134-PLKO</a:t>
              </a:r>
            </a:p>
          </p:txBody>
        </p:sp>
        <p:sp>
          <p:nvSpPr>
            <p:cNvPr id="22" name="TextBox 9">
              <a:extLst>
                <a:ext uri="{FF2B5EF4-FFF2-40B4-BE49-F238E27FC236}">
                  <a16:creationId xmlns:a16="http://schemas.microsoft.com/office/drawing/2014/main" id="{E01CFB99-7902-A3B6-AC26-04CE5E66A942}"/>
                </a:ext>
              </a:extLst>
            </p:cNvPr>
            <p:cNvSpPr txBox="1"/>
            <p:nvPr/>
          </p:nvSpPr>
          <p:spPr>
            <a:xfrm rot="16200000">
              <a:off x="1023758" y="4309422"/>
              <a:ext cx="955711" cy="26161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MB134TAMR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BDF596F-7D90-7AE5-B608-ABE5ACAD22F9}"/>
              </a:ext>
            </a:extLst>
          </p:cNvPr>
          <p:cNvGrpSpPr/>
          <p:nvPr/>
        </p:nvGrpSpPr>
        <p:grpSpPr>
          <a:xfrm>
            <a:off x="6730021" y="4455740"/>
            <a:ext cx="1696280" cy="1219884"/>
            <a:chOff x="2381713" y="3838154"/>
            <a:chExt cx="1696280" cy="1219884"/>
          </a:xfrm>
        </p:grpSpPr>
        <p:sp>
          <p:nvSpPr>
            <p:cNvPr id="24" name="TextBox 11">
              <a:extLst>
                <a:ext uri="{FF2B5EF4-FFF2-40B4-BE49-F238E27FC236}">
                  <a16:creationId xmlns:a16="http://schemas.microsoft.com/office/drawing/2014/main" id="{D8C9E499-948E-43E7-9A25-3EE588CCEE2A}"/>
                </a:ext>
              </a:extLst>
            </p:cNvPr>
            <p:cNvSpPr txBox="1"/>
            <p:nvPr/>
          </p:nvSpPr>
          <p:spPr>
            <a:xfrm rot="16200000">
              <a:off x="2009014" y="4233859"/>
              <a:ext cx="1007007" cy="26161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SUM44-PLKO</a:t>
              </a:r>
            </a:p>
          </p:txBody>
        </p:sp>
        <p:sp>
          <p:nvSpPr>
            <p:cNvPr id="25" name="TextBox 12">
              <a:extLst>
                <a:ext uri="{FF2B5EF4-FFF2-40B4-BE49-F238E27FC236}">
                  <a16:creationId xmlns:a16="http://schemas.microsoft.com/office/drawing/2014/main" id="{51A9CE84-DB4B-7DCA-054F-956EF51D309C}"/>
                </a:ext>
              </a:extLst>
            </p:cNvPr>
            <p:cNvSpPr txBox="1"/>
            <p:nvPr/>
          </p:nvSpPr>
          <p:spPr>
            <a:xfrm rot="16200000">
              <a:off x="2432161" y="4321138"/>
              <a:ext cx="1212191" cy="26161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SUM44-</a:t>
              </a:r>
              <a:r>
                <a:rPr lang="en-US" sz="1100" i="1" dirty="0"/>
                <a:t>shASS1</a:t>
              </a:r>
              <a:r>
                <a:rPr lang="en-US" sz="1100" dirty="0"/>
                <a:t>a</a:t>
              </a:r>
            </a:p>
          </p:txBody>
        </p:sp>
        <p:sp>
          <p:nvSpPr>
            <p:cNvPr id="26" name="TextBox 13">
              <a:extLst>
                <a:ext uri="{FF2B5EF4-FFF2-40B4-BE49-F238E27FC236}">
                  <a16:creationId xmlns:a16="http://schemas.microsoft.com/office/drawing/2014/main" id="{FA83B772-7C6B-3EAD-1A19-75C2777C6551}"/>
                </a:ext>
              </a:extLst>
            </p:cNvPr>
            <p:cNvSpPr txBox="1"/>
            <p:nvPr/>
          </p:nvSpPr>
          <p:spPr>
            <a:xfrm rot="16200000">
              <a:off x="2901469" y="4313445"/>
              <a:ext cx="1212191" cy="26161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SUM44-</a:t>
              </a:r>
              <a:r>
                <a:rPr lang="en-US" sz="1100" i="1" dirty="0"/>
                <a:t>shASS1</a:t>
              </a:r>
              <a:r>
                <a:rPr lang="en-US" sz="1100" dirty="0"/>
                <a:t>a</a:t>
              </a:r>
            </a:p>
          </p:txBody>
        </p:sp>
        <p:sp>
          <p:nvSpPr>
            <p:cNvPr id="27" name="TextBox 14">
              <a:extLst>
                <a:ext uri="{FF2B5EF4-FFF2-40B4-BE49-F238E27FC236}">
                  <a16:creationId xmlns:a16="http://schemas.microsoft.com/office/drawing/2014/main" id="{71576BC9-F640-BF9D-00C9-364D839C9704}"/>
                </a:ext>
              </a:extLst>
            </p:cNvPr>
            <p:cNvSpPr txBox="1"/>
            <p:nvPr/>
          </p:nvSpPr>
          <p:spPr>
            <a:xfrm rot="16200000">
              <a:off x="3461317" y="4200914"/>
              <a:ext cx="971741" cy="26161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SUM44TAMR</a:t>
              </a:r>
            </a:p>
          </p:txBody>
        </p:sp>
      </p:grpSp>
      <p:sp>
        <p:nvSpPr>
          <p:cNvPr id="28" name="TextBox 16">
            <a:extLst>
              <a:ext uri="{FF2B5EF4-FFF2-40B4-BE49-F238E27FC236}">
                <a16:creationId xmlns:a16="http://schemas.microsoft.com/office/drawing/2014/main" id="{0E23FF80-FB1F-A64C-4215-4A1E69848751}"/>
              </a:ext>
            </a:extLst>
          </p:cNvPr>
          <p:cNvSpPr txBox="1"/>
          <p:nvPr/>
        </p:nvSpPr>
        <p:spPr>
          <a:xfrm rot="16200000">
            <a:off x="5723589" y="4769929"/>
            <a:ext cx="1136755" cy="23812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MB134TAMR</a:t>
            </a:r>
          </a:p>
        </p:txBody>
      </p:sp>
      <p:sp>
        <p:nvSpPr>
          <p:cNvPr id="29" name="TextBox 9">
            <a:extLst>
              <a:ext uri="{FF2B5EF4-FFF2-40B4-BE49-F238E27FC236}">
                <a16:creationId xmlns:a16="http://schemas.microsoft.com/office/drawing/2014/main" id="{40957E15-9DD5-07A1-382B-6372A967AEFB}"/>
              </a:ext>
            </a:extLst>
          </p:cNvPr>
          <p:cNvSpPr txBox="1"/>
          <p:nvPr/>
        </p:nvSpPr>
        <p:spPr>
          <a:xfrm rot="16200000">
            <a:off x="4220786" y="4921895"/>
            <a:ext cx="1197764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MB134-</a:t>
            </a:r>
            <a:r>
              <a:rPr lang="en-US" sz="1100" i="1" dirty="0"/>
              <a:t>shASS1</a:t>
            </a:r>
            <a:r>
              <a:rPr lang="en-US" sz="1100" dirty="0"/>
              <a:t>a</a:t>
            </a:r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9B375590-A498-2D52-E0CC-5429032459E4}"/>
              </a:ext>
            </a:extLst>
          </p:cNvPr>
          <p:cNvSpPr txBox="1"/>
          <p:nvPr/>
        </p:nvSpPr>
        <p:spPr>
          <a:xfrm rot="16200000">
            <a:off x="4720658" y="4921895"/>
            <a:ext cx="1197764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MB134-</a:t>
            </a:r>
            <a:r>
              <a:rPr lang="en-US" sz="1100" i="1" dirty="0"/>
              <a:t>shASS1</a:t>
            </a:r>
            <a:r>
              <a:rPr lang="en-US" sz="1100" dirty="0"/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07A91A4-F34B-78D7-2001-B3E29EDDB415}"/>
              </a:ext>
            </a:extLst>
          </p:cNvPr>
          <p:cNvSpPr txBox="1"/>
          <p:nvPr/>
        </p:nvSpPr>
        <p:spPr>
          <a:xfrm>
            <a:off x="4773168" y="4166514"/>
            <a:ext cx="33915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MB134                                                                  SUM44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EE9406B-29D6-55EF-4B32-F6555A00423F}"/>
              </a:ext>
            </a:extLst>
          </p:cNvPr>
          <p:cNvCxnSpPr>
            <a:cxnSpLocks/>
          </p:cNvCxnSpPr>
          <p:nvPr/>
        </p:nvCxnSpPr>
        <p:spPr>
          <a:xfrm>
            <a:off x="4335645" y="4429749"/>
            <a:ext cx="1976865" cy="915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4BE3FF19-998F-5818-E56F-B15307054928}"/>
              </a:ext>
            </a:extLst>
          </p:cNvPr>
          <p:cNvCxnSpPr>
            <a:cxnSpLocks/>
          </p:cNvCxnSpPr>
          <p:nvPr/>
        </p:nvCxnSpPr>
        <p:spPr>
          <a:xfrm flipV="1">
            <a:off x="6823190" y="4397346"/>
            <a:ext cx="1689874" cy="32403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0A8D7058-AAB1-DB9A-A73D-0EAE69E38EA7}"/>
              </a:ext>
            </a:extLst>
          </p:cNvPr>
          <p:cNvSpPr txBox="1"/>
          <p:nvPr/>
        </p:nvSpPr>
        <p:spPr>
          <a:xfrm>
            <a:off x="3608290" y="1643763"/>
            <a:ext cx="4285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SS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67D8AB6-EAB2-376C-8CE9-434F136CB853}"/>
              </a:ext>
            </a:extLst>
          </p:cNvPr>
          <p:cNvSpPr txBox="1"/>
          <p:nvPr/>
        </p:nvSpPr>
        <p:spPr>
          <a:xfrm>
            <a:off x="3541188" y="3559628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8842647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4AECB2-F775-4B01-490C-D0E24B7271B3}"/>
              </a:ext>
            </a:extLst>
          </p:cNvPr>
          <p:cNvSpPr txBox="1"/>
          <p:nvPr/>
        </p:nvSpPr>
        <p:spPr>
          <a:xfrm>
            <a:off x="196558" y="317168"/>
            <a:ext cx="72649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 S6: B. </a:t>
            </a:r>
            <a:r>
              <a:rPr lang="en-US" sz="1600" dirty="0"/>
              <a:t>O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</a:rPr>
              <a:t>riginal W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ern blot</a:t>
            </a:r>
            <a:endParaRPr lang="en-US" sz="1600" dirty="0"/>
          </a:p>
          <a:p>
            <a:pPr algn="just"/>
            <a:endParaRPr lang="en-US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D90504D-9D18-CB1C-C9E9-2720FAFA930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52750"/>
          <a:stretch/>
        </p:blipFill>
        <p:spPr>
          <a:xfrm>
            <a:off x="1302789" y="4864242"/>
            <a:ext cx="1843170" cy="1729958"/>
          </a:xfrm>
          <a:prstGeom prst="rect">
            <a:avLst/>
          </a:prstGeom>
        </p:spPr>
      </p:pic>
      <p:sp>
        <p:nvSpPr>
          <p:cNvPr id="4" name="TextBox 86">
            <a:extLst>
              <a:ext uri="{FF2B5EF4-FFF2-40B4-BE49-F238E27FC236}">
                <a16:creationId xmlns:a16="http://schemas.microsoft.com/office/drawing/2014/main" id="{98E83330-7FBE-DAB3-D5BA-2C95C32EA29F}"/>
              </a:ext>
            </a:extLst>
          </p:cNvPr>
          <p:cNvSpPr txBox="1"/>
          <p:nvPr/>
        </p:nvSpPr>
        <p:spPr>
          <a:xfrm>
            <a:off x="652239" y="1891052"/>
            <a:ext cx="619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CA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87">
            <a:extLst>
              <a:ext uri="{FF2B5EF4-FFF2-40B4-BE49-F238E27FC236}">
                <a16:creationId xmlns:a16="http://schemas.microsoft.com/office/drawing/2014/main" id="{C2F42AF3-BCEB-AFAB-CBC7-0386A9538433}"/>
              </a:ext>
            </a:extLst>
          </p:cNvPr>
          <p:cNvSpPr txBox="1"/>
          <p:nvPr/>
        </p:nvSpPr>
        <p:spPr>
          <a:xfrm>
            <a:off x="683603" y="5426982"/>
            <a:ext cx="619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" name="TextBox 87">
            <a:extLst>
              <a:ext uri="{FF2B5EF4-FFF2-40B4-BE49-F238E27FC236}">
                <a16:creationId xmlns:a16="http://schemas.microsoft.com/office/drawing/2014/main" id="{C2F6F128-B16B-384C-15DE-FACE3BE63DE9}"/>
              </a:ext>
            </a:extLst>
          </p:cNvPr>
          <p:cNvSpPr txBox="1"/>
          <p:nvPr/>
        </p:nvSpPr>
        <p:spPr>
          <a:xfrm>
            <a:off x="810603" y="3659017"/>
            <a:ext cx="492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D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61E94EB-6746-4625-6DE2-22F06E24DE4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870" r="47080"/>
          <a:stretch/>
        </p:blipFill>
        <p:spPr>
          <a:xfrm>
            <a:off x="1290614" y="1107514"/>
            <a:ext cx="1843169" cy="1857634"/>
          </a:xfrm>
          <a:prstGeom prst="rect">
            <a:avLst/>
          </a:prstGeom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F3D8541E-8C78-485F-08CB-C34EB05190C3}"/>
              </a:ext>
            </a:extLst>
          </p:cNvPr>
          <p:cNvGrpSpPr/>
          <p:nvPr/>
        </p:nvGrpSpPr>
        <p:grpSpPr>
          <a:xfrm>
            <a:off x="1818907" y="2123961"/>
            <a:ext cx="731884" cy="940194"/>
            <a:chOff x="1053234" y="321404"/>
            <a:chExt cx="731736" cy="940194"/>
          </a:xfrm>
        </p:grpSpPr>
        <p:sp>
          <p:nvSpPr>
            <p:cNvPr id="9" name="TextBox 18">
              <a:extLst>
                <a:ext uri="{FF2B5EF4-FFF2-40B4-BE49-F238E27FC236}">
                  <a16:creationId xmlns:a16="http://schemas.microsoft.com/office/drawing/2014/main" id="{90ED5530-CC5A-4BCC-F3F2-819309DF3F91}"/>
                </a:ext>
              </a:extLst>
            </p:cNvPr>
            <p:cNvSpPr txBox="1"/>
            <p:nvPr/>
          </p:nvSpPr>
          <p:spPr>
            <a:xfrm rot="16200000">
              <a:off x="830406" y="669684"/>
              <a:ext cx="708079" cy="26242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SUM44-P</a:t>
              </a:r>
            </a:p>
          </p:txBody>
        </p:sp>
        <p:sp>
          <p:nvSpPr>
            <p:cNvPr id="10" name="TextBox 19">
              <a:extLst>
                <a:ext uri="{FF2B5EF4-FFF2-40B4-BE49-F238E27FC236}">
                  <a16:creationId xmlns:a16="http://schemas.microsoft.com/office/drawing/2014/main" id="{26E1060F-7EC0-C1FF-C35F-08AF45009640}"/>
                </a:ext>
              </a:extLst>
            </p:cNvPr>
            <p:cNvSpPr txBox="1"/>
            <p:nvPr/>
          </p:nvSpPr>
          <p:spPr>
            <a:xfrm rot="16200000">
              <a:off x="1183661" y="660289"/>
              <a:ext cx="940194" cy="26242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SUM44-PLKO</a:t>
              </a:r>
            </a:p>
          </p:txBody>
        </p: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595BD8C7-7BB4-672E-FB29-549C7DCEC1D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0066" t="30583" r="48544"/>
          <a:stretch/>
        </p:blipFill>
        <p:spPr>
          <a:xfrm>
            <a:off x="3337369" y="1086415"/>
            <a:ext cx="2194560" cy="184860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2F9566F-DC99-865F-7A80-1B7F6997AD4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53385" b="4923"/>
          <a:stretch/>
        </p:blipFill>
        <p:spPr>
          <a:xfrm>
            <a:off x="3326498" y="2935020"/>
            <a:ext cx="2216301" cy="1729958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9FEADA43-A110-188D-EAFE-DECCA03FA11A}"/>
              </a:ext>
            </a:extLst>
          </p:cNvPr>
          <p:cNvGrpSpPr/>
          <p:nvPr/>
        </p:nvGrpSpPr>
        <p:grpSpPr>
          <a:xfrm>
            <a:off x="3841159" y="1976577"/>
            <a:ext cx="1207941" cy="990977"/>
            <a:chOff x="632" y="101354"/>
            <a:chExt cx="1166697" cy="865086"/>
          </a:xfrm>
        </p:grpSpPr>
        <p:sp>
          <p:nvSpPr>
            <p:cNvPr id="15" name="TextBox 8">
              <a:extLst>
                <a:ext uri="{FF2B5EF4-FFF2-40B4-BE49-F238E27FC236}">
                  <a16:creationId xmlns:a16="http://schemas.microsoft.com/office/drawing/2014/main" id="{968B942C-FC1B-7D85-5EA4-FF13E8D4624B}"/>
                </a:ext>
              </a:extLst>
            </p:cNvPr>
            <p:cNvSpPr txBox="1"/>
            <p:nvPr/>
          </p:nvSpPr>
          <p:spPr>
            <a:xfrm rot="16200000">
              <a:off x="-195023" y="497813"/>
              <a:ext cx="643987" cy="2526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/>
                <a:t>MB134-P</a:t>
              </a:r>
            </a:p>
          </p:txBody>
        </p:sp>
        <p:sp>
          <p:nvSpPr>
            <p:cNvPr id="16" name="TextBox 9">
              <a:extLst>
                <a:ext uri="{FF2B5EF4-FFF2-40B4-BE49-F238E27FC236}">
                  <a16:creationId xmlns:a16="http://schemas.microsoft.com/office/drawing/2014/main" id="{B1832393-8B43-2B4D-72F5-72C09B1932EA}"/>
                </a:ext>
              </a:extLst>
            </p:cNvPr>
            <p:cNvSpPr txBox="1"/>
            <p:nvPr/>
          </p:nvSpPr>
          <p:spPr>
            <a:xfrm rot="16200000">
              <a:off x="281230" y="479973"/>
              <a:ext cx="643987" cy="2526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MB134-P</a:t>
              </a:r>
            </a:p>
          </p:txBody>
        </p:sp>
        <p:sp>
          <p:nvSpPr>
            <p:cNvPr id="17" name="TextBox 10">
              <a:extLst>
                <a:ext uri="{FF2B5EF4-FFF2-40B4-BE49-F238E27FC236}">
                  <a16:creationId xmlns:a16="http://schemas.microsoft.com/office/drawing/2014/main" id="{056E20F1-262A-E505-12F2-B7DE208860A3}"/>
                </a:ext>
              </a:extLst>
            </p:cNvPr>
            <p:cNvSpPr txBox="1"/>
            <p:nvPr/>
          </p:nvSpPr>
          <p:spPr>
            <a:xfrm rot="16200000">
              <a:off x="608447" y="407558"/>
              <a:ext cx="865086" cy="2526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/>
                <a:t>MB134-PLKO</a:t>
              </a:r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EC06CD01-D124-F7A5-00F4-6E2E762260B1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r="59236" b="2716"/>
          <a:stretch/>
        </p:blipFill>
        <p:spPr>
          <a:xfrm>
            <a:off x="3326498" y="4664978"/>
            <a:ext cx="2216301" cy="190913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0B049C3-C570-35E3-0D97-709689ACC67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89714" y="2980726"/>
            <a:ext cx="1843169" cy="181278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FC00BC8-E861-C343-751D-447DCDF740AB}"/>
              </a:ext>
            </a:extLst>
          </p:cNvPr>
          <p:cNvSpPr txBox="1"/>
          <p:nvPr/>
        </p:nvSpPr>
        <p:spPr>
          <a:xfrm>
            <a:off x="2036369" y="882254"/>
            <a:ext cx="6208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M44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11E9523-7D77-8D66-25F9-EC18CD7304DD}"/>
              </a:ext>
            </a:extLst>
          </p:cNvPr>
          <p:cNvCxnSpPr>
            <a:cxnSpLocks/>
          </p:cNvCxnSpPr>
          <p:nvPr/>
        </p:nvCxnSpPr>
        <p:spPr>
          <a:xfrm flipV="1">
            <a:off x="9410942" y="2665427"/>
            <a:ext cx="1689874" cy="32403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7B13E748-5BD3-BDB9-4B02-6BA22E0B0DA4}"/>
              </a:ext>
            </a:extLst>
          </p:cNvPr>
          <p:cNvSpPr txBox="1"/>
          <p:nvPr/>
        </p:nvSpPr>
        <p:spPr>
          <a:xfrm>
            <a:off x="4285427" y="902864"/>
            <a:ext cx="620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B134	</a:t>
            </a:r>
          </a:p>
        </p:txBody>
      </p:sp>
      <p:sp>
        <p:nvSpPr>
          <p:cNvPr id="24" name="TextBox 86">
            <a:extLst>
              <a:ext uri="{FF2B5EF4-FFF2-40B4-BE49-F238E27FC236}">
                <a16:creationId xmlns:a16="http://schemas.microsoft.com/office/drawing/2014/main" id="{17ECFC66-9B00-A420-12E2-16EF0E8D6AC0}"/>
              </a:ext>
            </a:extLst>
          </p:cNvPr>
          <p:cNvSpPr txBox="1"/>
          <p:nvPr/>
        </p:nvSpPr>
        <p:spPr>
          <a:xfrm>
            <a:off x="5531929" y="1629442"/>
            <a:ext cx="619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CA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87">
            <a:extLst>
              <a:ext uri="{FF2B5EF4-FFF2-40B4-BE49-F238E27FC236}">
                <a16:creationId xmlns:a16="http://schemas.microsoft.com/office/drawing/2014/main" id="{14C7988E-2D15-457C-2BA8-6C6C24C03951}"/>
              </a:ext>
            </a:extLst>
          </p:cNvPr>
          <p:cNvSpPr txBox="1"/>
          <p:nvPr/>
        </p:nvSpPr>
        <p:spPr>
          <a:xfrm>
            <a:off x="5479796" y="5296177"/>
            <a:ext cx="619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6" name="TextBox 87">
            <a:extLst>
              <a:ext uri="{FF2B5EF4-FFF2-40B4-BE49-F238E27FC236}">
                <a16:creationId xmlns:a16="http://schemas.microsoft.com/office/drawing/2014/main" id="{40101DAE-C00D-97C1-7F2D-3AC620D36B25}"/>
              </a:ext>
            </a:extLst>
          </p:cNvPr>
          <p:cNvSpPr txBox="1"/>
          <p:nvPr/>
        </p:nvSpPr>
        <p:spPr>
          <a:xfrm>
            <a:off x="5504325" y="3480919"/>
            <a:ext cx="492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D</a:t>
            </a:r>
          </a:p>
        </p:txBody>
      </p:sp>
      <p:sp>
        <p:nvSpPr>
          <p:cNvPr id="27" name="TextBox 9">
            <a:extLst>
              <a:ext uri="{FF2B5EF4-FFF2-40B4-BE49-F238E27FC236}">
                <a16:creationId xmlns:a16="http://schemas.microsoft.com/office/drawing/2014/main" id="{18D1A4E9-8910-807D-ACEC-B3DB6457B7F6}"/>
              </a:ext>
            </a:extLst>
          </p:cNvPr>
          <p:cNvSpPr txBox="1"/>
          <p:nvPr/>
        </p:nvSpPr>
        <p:spPr>
          <a:xfrm rot="16200000">
            <a:off x="4728561" y="2292469"/>
            <a:ext cx="1197764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MB134-</a:t>
            </a:r>
            <a:r>
              <a:rPr lang="en-US" sz="1100" i="1" dirty="0"/>
              <a:t>shASS1</a:t>
            </a:r>
            <a:r>
              <a:rPr lang="en-US" sz="1100" dirty="0"/>
              <a:t>a</a:t>
            </a:r>
          </a:p>
        </p:txBody>
      </p:sp>
      <p:sp>
        <p:nvSpPr>
          <p:cNvPr id="28" name="TextBox 13">
            <a:extLst>
              <a:ext uri="{FF2B5EF4-FFF2-40B4-BE49-F238E27FC236}">
                <a16:creationId xmlns:a16="http://schemas.microsoft.com/office/drawing/2014/main" id="{C983148F-805E-4AF8-5B85-46F20B1BD7F4}"/>
              </a:ext>
            </a:extLst>
          </p:cNvPr>
          <p:cNvSpPr txBox="1"/>
          <p:nvPr/>
        </p:nvSpPr>
        <p:spPr>
          <a:xfrm rot="16200000">
            <a:off x="2247237" y="2534621"/>
            <a:ext cx="1212191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SUM44-</a:t>
            </a:r>
            <a:r>
              <a:rPr lang="en-US" sz="1100" i="1" dirty="0"/>
              <a:t>shASS1</a:t>
            </a:r>
            <a:r>
              <a:rPr lang="en-US" sz="11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707640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234</Words>
  <Application>Microsoft Office PowerPoint</Application>
  <PresentationFormat>Widescreen</PresentationFormat>
  <Paragraphs>13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upta, Annapurna</dc:creator>
  <cp:lastModifiedBy>Majumder, Sarmila</cp:lastModifiedBy>
  <cp:revision>11</cp:revision>
  <dcterms:created xsi:type="dcterms:W3CDTF">2024-09-25T17:35:50Z</dcterms:created>
  <dcterms:modified xsi:type="dcterms:W3CDTF">2025-03-13T20:49:51Z</dcterms:modified>
</cp:coreProperties>
</file>